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627813" cy="8229600"/>
  <p:notesSz cx="6735763" cy="98679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C524E5-4C01-4EB8-A3C9-5239382A6F1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31560" y="330120"/>
            <a:ext cx="596412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31560" y="1920960"/>
            <a:ext cx="5964120" cy="259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31560" y="4758480"/>
            <a:ext cx="5964120" cy="259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989A08-132C-491B-955E-7D6EE9F3F50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31560" y="330120"/>
            <a:ext cx="596412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31560" y="1920960"/>
            <a:ext cx="2910240" cy="259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387600" y="1920960"/>
            <a:ext cx="2910240" cy="259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31560" y="4758480"/>
            <a:ext cx="2910240" cy="259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387600" y="4758480"/>
            <a:ext cx="2910240" cy="259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BC1DF7-C1B8-4E6A-BE3E-78FEE8E1CBF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31560" y="330120"/>
            <a:ext cx="596412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31560" y="1920960"/>
            <a:ext cx="1920240" cy="259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348280" y="1920960"/>
            <a:ext cx="1920240" cy="259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365000" y="1920960"/>
            <a:ext cx="1920240" cy="259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31560" y="4758480"/>
            <a:ext cx="1920240" cy="259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348280" y="4758480"/>
            <a:ext cx="1920240" cy="259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365000" y="4758480"/>
            <a:ext cx="1920240" cy="259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B9F43F-192B-4C1D-B8D3-B502AF25BAF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31560" y="330120"/>
            <a:ext cx="596412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31560" y="1920960"/>
            <a:ext cx="5964120" cy="5432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3BB5B3-60D2-40FD-AF12-880CC18F230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31560" y="330120"/>
            <a:ext cx="596412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31560" y="1920960"/>
            <a:ext cx="5964120" cy="5432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1E341A-A4B0-4EBF-BFE4-DDD3D3992C7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31560" y="330120"/>
            <a:ext cx="596412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31560" y="1920960"/>
            <a:ext cx="2910240" cy="5432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387600" y="1920960"/>
            <a:ext cx="2910240" cy="5432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F262B1-A68A-4766-97CC-9AB5CB3164D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31560" y="330120"/>
            <a:ext cx="596412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C47978-CDBF-4CED-8AB0-E0F6F36E31D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31560" y="330120"/>
            <a:ext cx="5964120" cy="6359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F7A090-3239-45BE-A2A6-CC84911AD53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31560" y="330120"/>
            <a:ext cx="596412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31560" y="1920960"/>
            <a:ext cx="2910240" cy="259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387600" y="1920960"/>
            <a:ext cx="2910240" cy="5432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31560" y="4758480"/>
            <a:ext cx="2910240" cy="259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02B8BD-07BA-4242-8960-F9CBE43EAD4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31560" y="330120"/>
            <a:ext cx="596412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31560" y="1920960"/>
            <a:ext cx="2910240" cy="5432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387600" y="1920960"/>
            <a:ext cx="2910240" cy="259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387600" y="4758480"/>
            <a:ext cx="2910240" cy="259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6DDF76-DE1A-42DA-845F-91F0FE63E21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31560" y="330120"/>
            <a:ext cx="596412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31560" y="1920960"/>
            <a:ext cx="2910240" cy="259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387600" y="1920960"/>
            <a:ext cx="2910240" cy="259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31560" y="4758480"/>
            <a:ext cx="5964120" cy="259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1C4495-2EF8-470E-81E3-8D1AEBFC0C5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31560" y="330120"/>
            <a:ext cx="596412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31560" y="1920960"/>
            <a:ext cx="5964120" cy="5432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31560" y="7495920"/>
            <a:ext cx="1546200" cy="57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263680" y="7495920"/>
            <a:ext cx="2100240" cy="57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749480" y="7495920"/>
            <a:ext cx="1546200" cy="57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2345CC9-9BC6-410F-B41F-6837CC390ED9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7"/>
          <p:cNvSpPr/>
          <p:nvPr/>
        </p:nvSpPr>
        <p:spPr>
          <a:xfrm>
            <a:off x="352440" y="155520"/>
            <a:ext cx="31370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Table S3.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 Primer sequence used for the cloning analysis.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 Box 8"/>
          <p:cNvSpPr/>
          <p:nvPr/>
        </p:nvSpPr>
        <p:spPr>
          <a:xfrm>
            <a:off x="398880" y="2451240"/>
            <a:ext cx="60145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*Primer 1 was used for preparing PCR product with Gotaq</a:t>
            </a:r>
            <a:r>
              <a:rPr b="0" lang="en-US" sz="8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®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 DNA polymerase.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**Primer 2 was used for preparing PCR product with PrimeSTAR</a:t>
            </a:r>
            <a:r>
              <a:rPr b="0" lang="en-US" sz="8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®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 GXL DNA polymerase. The sequence of vector specific part is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on underline. 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Line 12"/>
          <p:cNvSpPr/>
          <p:nvPr/>
        </p:nvSpPr>
        <p:spPr>
          <a:xfrm>
            <a:off x="455760" y="555480"/>
            <a:ext cx="5715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Line 11"/>
          <p:cNvSpPr/>
          <p:nvPr/>
        </p:nvSpPr>
        <p:spPr>
          <a:xfrm>
            <a:off x="455760" y="2427120"/>
            <a:ext cx="5715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Line 10"/>
          <p:cNvSpPr/>
          <p:nvPr/>
        </p:nvSpPr>
        <p:spPr>
          <a:xfrm>
            <a:off x="455760" y="1851120"/>
            <a:ext cx="5715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Rectangle 13"/>
          <p:cNvSpPr/>
          <p:nvPr/>
        </p:nvSpPr>
        <p:spPr>
          <a:xfrm>
            <a:off x="793800" y="370800"/>
            <a:ext cx="8665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8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KRAS </a:t>
            </a: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mutatio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Rectangle 14"/>
          <p:cNvSpPr/>
          <p:nvPr/>
        </p:nvSpPr>
        <p:spPr>
          <a:xfrm>
            <a:off x="824040" y="531720"/>
            <a:ext cx="497808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F-Primer-1*</a:t>
            </a:r>
            <a:r>
              <a:rPr b="0" lang="en-US" sz="8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	</a:t>
            </a:r>
            <a:r>
              <a:rPr b="0" lang="en-US" sz="8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GAATGGTCCTGCACCAGTAA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R-Primer-1*</a:t>
            </a:r>
            <a:r>
              <a:rPr b="0" lang="en-US" sz="8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	</a:t>
            </a:r>
            <a:r>
              <a:rPr b="0" lang="en-US" sz="8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GTGTGACATGTTCTAATATAGTC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F-Primer-2**</a:t>
            </a:r>
            <a:r>
              <a:rPr b="0" lang="en-US" sz="8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	</a:t>
            </a:r>
            <a:r>
              <a:rPr b="0" lang="en-US" sz="800" spc="-1" strike="noStrike" u="sng">
                <a:solidFill>
                  <a:srgbClr val="000000"/>
                </a:solidFill>
                <a:uFillTx/>
                <a:latin typeface="Times New Roman"/>
                <a:ea typeface="ＭＳ 明朝"/>
              </a:rPr>
              <a:t>GGATCTTCCAGAGATATC</a:t>
            </a:r>
            <a:r>
              <a:rPr b="0" lang="en-US" sz="8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GAATGGTCCTGCACCAGTA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R-Primer-2**</a:t>
            </a:r>
            <a:r>
              <a:rPr b="0" lang="en-US" sz="8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	</a:t>
            </a:r>
            <a:r>
              <a:rPr b="0" lang="en-US" sz="800" spc="-1" strike="noStrike" u="sng">
                <a:solidFill>
                  <a:srgbClr val="000000"/>
                </a:solidFill>
                <a:uFillTx/>
                <a:latin typeface="Times New Roman"/>
                <a:ea typeface="ＭＳ 明朝"/>
              </a:rPr>
              <a:t>CTGCCGTTCGACGATATC</a:t>
            </a:r>
            <a:r>
              <a:rPr b="0" lang="en-US" sz="8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GTGTGACATGTTCTAATATAG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Rectangle 15"/>
          <p:cNvSpPr/>
          <p:nvPr/>
        </p:nvSpPr>
        <p:spPr>
          <a:xfrm>
            <a:off x="831960" y="1298160"/>
            <a:ext cx="3759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F-Primer-1*</a:t>
            </a:r>
            <a:r>
              <a:rPr b="0" lang="en-US" sz="8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	</a:t>
            </a:r>
            <a:r>
              <a:rPr b="0" lang="en-US" sz="8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TGCTTGCTCTGATAGGAAAAT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R-Primer-1*</a:t>
            </a:r>
            <a:r>
              <a:rPr b="0" lang="en-US" sz="8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	</a:t>
            </a:r>
            <a:r>
              <a:rPr b="0" lang="en-US" sz="8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AGCATCTCAGGGCCAAAAA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Rectangle 16"/>
          <p:cNvSpPr/>
          <p:nvPr/>
        </p:nvSpPr>
        <p:spPr>
          <a:xfrm>
            <a:off x="821880" y="1846440"/>
            <a:ext cx="494460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F-Primer-1*</a:t>
            </a:r>
            <a:r>
              <a:rPr b="0" lang="en-US" sz="8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	</a:t>
            </a:r>
            <a:r>
              <a:rPr b="0" lang="en-US" sz="8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CTGTGAATCCAGAGGGGAA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R-Primer-1*</a:t>
            </a:r>
            <a:r>
              <a:rPr b="0" lang="en-US" sz="8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	</a:t>
            </a:r>
            <a:r>
              <a:rPr b="0" lang="en-US" sz="8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ACATGCTGAGATCAGCCAAA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F-Primer-2**</a:t>
            </a:r>
            <a:r>
              <a:rPr b="0" lang="en-US" sz="8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	</a:t>
            </a:r>
            <a:r>
              <a:rPr b="0" lang="en-US" sz="800" spc="-1" strike="noStrike" u="sng">
                <a:solidFill>
                  <a:srgbClr val="000000"/>
                </a:solidFill>
                <a:uFillTx/>
                <a:latin typeface="Times New Roman"/>
                <a:ea typeface="ＭＳ 明朝"/>
              </a:rPr>
              <a:t>GGATCTTCCAGAGATATC</a:t>
            </a:r>
            <a:r>
              <a:rPr b="0" lang="en-US" sz="8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CTGTGAATCCAGAGGGGAA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0574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R-Primer-2**</a:t>
            </a:r>
            <a:r>
              <a:rPr b="0" lang="en-US" sz="8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	</a:t>
            </a:r>
            <a:r>
              <a:rPr b="0" lang="en-US" sz="800" spc="-1" strike="noStrike" u="sng">
                <a:solidFill>
                  <a:srgbClr val="000000"/>
                </a:solidFill>
                <a:uFillTx/>
                <a:latin typeface="Times New Roman"/>
                <a:ea typeface="ＭＳ 明朝"/>
              </a:rPr>
              <a:t>CTGCCGTTCGACGATATC</a:t>
            </a:r>
            <a:r>
              <a:rPr b="0" lang="en-US" sz="8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ACATGCTGAGATCAGCCAAA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Line 17"/>
          <p:cNvSpPr/>
          <p:nvPr/>
        </p:nvSpPr>
        <p:spPr>
          <a:xfrm>
            <a:off x="455760" y="1322280"/>
            <a:ext cx="5715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Rectangle 18"/>
          <p:cNvSpPr/>
          <p:nvPr/>
        </p:nvSpPr>
        <p:spPr>
          <a:xfrm>
            <a:off x="790200" y="1132920"/>
            <a:ext cx="8787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8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BRAF </a:t>
            </a: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mutatio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Rectangle 19"/>
          <p:cNvSpPr/>
          <p:nvPr/>
        </p:nvSpPr>
        <p:spPr>
          <a:xfrm>
            <a:off x="3850920" y="372600"/>
            <a:ext cx="956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Sequence (5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  <a:ea typeface="ＭＳ 明朝"/>
              </a:rPr>
              <a:t>’</a:t>
            </a: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 </a:t>
            </a:r>
            <a:r>
              <a:rPr b="1" lang="en-US" sz="800" spc="-1" strike="noStrike">
                <a:solidFill>
                  <a:srgbClr val="000000"/>
                </a:solidFill>
                <a:latin typeface="ＭＳ 明朝"/>
                <a:ea typeface="ＭＳ 明朝"/>
              </a:rPr>
              <a:t>➝</a:t>
            </a: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 3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  <a:ea typeface="ＭＳ 明朝"/>
              </a:rPr>
              <a:t>’</a:t>
            </a: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Rectangle 20"/>
          <p:cNvSpPr/>
          <p:nvPr/>
        </p:nvSpPr>
        <p:spPr>
          <a:xfrm>
            <a:off x="3850920" y="1132920"/>
            <a:ext cx="956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Sequence (5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  <a:ea typeface="ＭＳ 明朝"/>
              </a:rPr>
              <a:t>’</a:t>
            </a: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 </a:t>
            </a:r>
            <a:r>
              <a:rPr b="1" lang="en-US" sz="800" spc="-1" strike="noStrike">
                <a:solidFill>
                  <a:srgbClr val="000000"/>
                </a:solidFill>
                <a:latin typeface="ＭＳ 明朝"/>
                <a:ea typeface="ＭＳ 明朝"/>
              </a:rPr>
              <a:t>➝</a:t>
            </a: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 3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  <a:ea typeface="ＭＳ 明朝"/>
              </a:rPr>
              <a:t>’</a:t>
            </a: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Rectangle 21"/>
          <p:cNvSpPr/>
          <p:nvPr/>
        </p:nvSpPr>
        <p:spPr>
          <a:xfrm>
            <a:off x="795240" y="1658160"/>
            <a:ext cx="10508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8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PIK3CA</a:t>
            </a:r>
            <a:r>
              <a:rPr b="1" i="1" lang="en-US" sz="800" spc="-1" strike="noStrike" baseline="30000">
                <a:solidFill>
                  <a:srgbClr val="000000"/>
                </a:solidFill>
                <a:latin typeface="Times New Roman"/>
                <a:ea typeface="ＭＳ 明朝"/>
              </a:rPr>
              <a:t>ex9</a:t>
            </a:r>
            <a:r>
              <a:rPr b="1" i="1" lang="en-US" sz="8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 </a:t>
            </a: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mutatio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Rectangle 22"/>
          <p:cNvSpPr/>
          <p:nvPr/>
        </p:nvSpPr>
        <p:spPr>
          <a:xfrm>
            <a:off x="3854160" y="1658160"/>
            <a:ext cx="956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Sequence (5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  <a:ea typeface="ＭＳ 明朝"/>
              </a:rPr>
              <a:t>’</a:t>
            </a: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 </a:t>
            </a:r>
            <a:r>
              <a:rPr b="1" lang="en-US" sz="800" spc="-1" strike="noStrike">
                <a:solidFill>
                  <a:srgbClr val="000000"/>
                </a:solidFill>
                <a:latin typeface="ＭＳ 明朝"/>
                <a:ea typeface="ＭＳ 明朝"/>
              </a:rPr>
              <a:t>➝</a:t>
            </a: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 3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  <a:ea typeface="ＭＳ 明朝"/>
              </a:rPr>
              <a:t>’</a:t>
            </a: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521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2-20T10:28:37Z</dcterms:created>
  <dc:creator>LS</dc:creator>
  <dc:description/>
  <dc:language>en-US</dc:language>
  <cp:lastModifiedBy>凸版印刷社員</cp:lastModifiedBy>
  <dcterms:modified xsi:type="dcterms:W3CDTF">2013-01-07T09:11:51Z</dcterms:modified>
  <cp:revision>52</cp:revision>
  <dc:subject/>
  <dc:title>スライド 1</dc:title>
</cp:coreProperties>
</file>